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6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243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1501008922018999E-2"/>
          <c:y val="2.6121018472907698E-2"/>
          <c:w val="0.90190977076493495"/>
          <c:h val="0.90422293226600503"/>
        </c:manualLayout>
      </c:layout>
      <c:scatterChart>
        <c:scatterStyle val="lineMarker"/>
        <c:varyColors val="0"/>
        <c:ser>
          <c:idx val="0"/>
          <c:order val="0"/>
          <c:tx>
            <c:strRef>
              <c:f>'thy logfc by logfc'!$L$1</c:f>
              <c:strCache>
                <c:ptCount val="1"/>
                <c:pt idx="0">
                  <c:v>logFC.coef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9.8815480467856001E-3"/>
                  <c:y val="-2.5402519067143699E-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baseline="0" dirty="0"/>
                      <a:t>R² = 0.8631</a:t>
                    </a:r>
                    <a:endParaRPr lang="en-US" dirty="0"/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thy logfc by logfc'!$J$2:$J$14894</c:f>
              <c:numCache>
                <c:formatCode>General</c:formatCode>
                <c:ptCount val="14893"/>
                <c:pt idx="0">
                  <c:v>2.9966510267381832</c:v>
                </c:pt>
                <c:pt idx="1">
                  <c:v>2.96332764113528</c:v>
                </c:pt>
                <c:pt idx="2">
                  <c:v>0.89562574985983201</c:v>
                </c:pt>
                <c:pt idx="3">
                  <c:v>1.08125583033331</c:v>
                </c:pt>
                <c:pt idx="4">
                  <c:v>2.0625215779258101</c:v>
                </c:pt>
                <c:pt idx="5">
                  <c:v>0.83614391417546197</c:v>
                </c:pt>
                <c:pt idx="6">
                  <c:v>0.88594780470416701</c:v>
                </c:pt>
                <c:pt idx="7">
                  <c:v>0.47496399375724302</c:v>
                </c:pt>
                <c:pt idx="8">
                  <c:v>0.467691403701881</c:v>
                </c:pt>
                <c:pt idx="9">
                  <c:v>0.74480612969624604</c:v>
                </c:pt>
                <c:pt idx="10">
                  <c:v>0.79476458599081301</c:v>
                </c:pt>
                <c:pt idx="11">
                  <c:v>0.55896583657572796</c:v>
                </c:pt>
                <c:pt idx="12">
                  <c:v>0.60348698043317905</c:v>
                </c:pt>
                <c:pt idx="13">
                  <c:v>0.98187709999999995</c:v>
                </c:pt>
                <c:pt idx="14">
                  <c:v>0.47019539587571502</c:v>
                </c:pt>
                <c:pt idx="15">
                  <c:v>0.88651882118874004</c:v>
                </c:pt>
                <c:pt idx="16">
                  <c:v>0.83036178579705699</c:v>
                </c:pt>
                <c:pt idx="17">
                  <c:v>0.73339270000000001</c:v>
                </c:pt>
                <c:pt idx="18">
                  <c:v>0.467635870943096</c:v>
                </c:pt>
                <c:pt idx="19">
                  <c:v>1.2791644556762001</c:v>
                </c:pt>
                <c:pt idx="20">
                  <c:v>0.28239482180384801</c:v>
                </c:pt>
                <c:pt idx="21">
                  <c:v>0.64526621525925099</c:v>
                </c:pt>
                <c:pt idx="22">
                  <c:v>0.67248599187624702</c:v>
                </c:pt>
                <c:pt idx="23">
                  <c:v>1.1358546733771799</c:v>
                </c:pt>
                <c:pt idx="24">
                  <c:v>0.70314812742140198</c:v>
                </c:pt>
                <c:pt idx="25">
                  <c:v>1.0465928939248199</c:v>
                </c:pt>
                <c:pt idx="26">
                  <c:v>0.61528410350975005</c:v>
                </c:pt>
                <c:pt idx="27">
                  <c:v>0.47423744285102498</c:v>
                </c:pt>
                <c:pt idx="28">
                  <c:v>0.34918313142305801</c:v>
                </c:pt>
                <c:pt idx="29">
                  <c:v>0.36248646598835699</c:v>
                </c:pt>
                <c:pt idx="30">
                  <c:v>0.462250553528404</c:v>
                </c:pt>
                <c:pt idx="31">
                  <c:v>0.34678819336211802</c:v>
                </c:pt>
                <c:pt idx="32">
                  <c:v>0.30058016391609199</c:v>
                </c:pt>
                <c:pt idx="33">
                  <c:v>0.355673471821981</c:v>
                </c:pt>
                <c:pt idx="34">
                  <c:v>0.34703548119941102</c:v>
                </c:pt>
                <c:pt idx="35">
                  <c:v>1.08378785385426</c:v>
                </c:pt>
                <c:pt idx="36">
                  <c:v>1.3299307697342899</c:v>
                </c:pt>
                <c:pt idx="37">
                  <c:v>0.58288268698697998</c:v>
                </c:pt>
                <c:pt idx="38">
                  <c:v>0.41477758222946098</c:v>
                </c:pt>
                <c:pt idx="39">
                  <c:v>0.48407314017912201</c:v>
                </c:pt>
                <c:pt idx="40">
                  <c:v>-0.49541570694999998</c:v>
                </c:pt>
                <c:pt idx="41">
                  <c:v>0.45309178509189801</c:v>
                </c:pt>
                <c:pt idx="42">
                  <c:v>0.31776996208691399</c:v>
                </c:pt>
                <c:pt idx="43">
                  <c:v>0.51094533622342397</c:v>
                </c:pt>
                <c:pt idx="44">
                  <c:v>1.84569034499297</c:v>
                </c:pt>
                <c:pt idx="45">
                  <c:v>0.39594439796925002</c:v>
                </c:pt>
                <c:pt idx="46">
                  <c:v>0.77669744441505595</c:v>
                </c:pt>
                <c:pt idx="47">
                  <c:v>0.32011049879583198</c:v>
                </c:pt>
                <c:pt idx="48">
                  <c:v>-0.34978896462479597</c:v>
                </c:pt>
                <c:pt idx="49">
                  <c:v>0.55540668235952595</c:v>
                </c:pt>
                <c:pt idx="50">
                  <c:v>0.37651391580959798</c:v>
                </c:pt>
                <c:pt idx="51">
                  <c:v>0.35954354731716498</c:v>
                </c:pt>
                <c:pt idx="52">
                  <c:v>0.74311457472307096</c:v>
                </c:pt>
                <c:pt idx="53">
                  <c:v>0.28555513727994303</c:v>
                </c:pt>
                <c:pt idx="54">
                  <c:v>0.350438497236086</c:v>
                </c:pt>
                <c:pt idx="55">
                  <c:v>0.37450085537585598</c:v>
                </c:pt>
                <c:pt idx="56">
                  <c:v>0.47826397663481002</c:v>
                </c:pt>
                <c:pt idx="57">
                  <c:v>0.72707432118354798</c:v>
                </c:pt>
                <c:pt idx="58">
                  <c:v>0.58184484832865402</c:v>
                </c:pt>
                <c:pt idx="59">
                  <c:v>0.85959906526454699</c:v>
                </c:pt>
                <c:pt idx="60">
                  <c:v>0.96959280000000003</c:v>
                </c:pt>
                <c:pt idx="61">
                  <c:v>0.40504496620071001</c:v>
                </c:pt>
                <c:pt idx="62">
                  <c:v>0.29657280737507802</c:v>
                </c:pt>
                <c:pt idx="63">
                  <c:v>1.3883021648615499</c:v>
                </c:pt>
                <c:pt idx="64">
                  <c:v>0.26056384042349801</c:v>
                </c:pt>
                <c:pt idx="65">
                  <c:v>0.44251082147896798</c:v>
                </c:pt>
                <c:pt idx="66">
                  <c:v>0.48615895810827697</c:v>
                </c:pt>
                <c:pt idx="67">
                  <c:v>0.56507543306389896</c:v>
                </c:pt>
                <c:pt idx="68">
                  <c:v>0.25934899724351101</c:v>
                </c:pt>
                <c:pt idx="69">
                  <c:v>1.2968796192882699</c:v>
                </c:pt>
                <c:pt idx="70">
                  <c:v>0.55910209910935904</c:v>
                </c:pt>
                <c:pt idx="71">
                  <c:v>0.45252475006034498</c:v>
                </c:pt>
                <c:pt idx="72">
                  <c:v>0.35809040903677603</c:v>
                </c:pt>
                <c:pt idx="73">
                  <c:v>0.220575015823992</c:v>
                </c:pt>
                <c:pt idx="74">
                  <c:v>-0.36448158057260399</c:v>
                </c:pt>
                <c:pt idx="75">
                  <c:v>0.421414622286088</c:v>
                </c:pt>
                <c:pt idx="76">
                  <c:v>0.205503722262046</c:v>
                </c:pt>
                <c:pt idx="77">
                  <c:v>-0.62140707782036597</c:v>
                </c:pt>
                <c:pt idx="78">
                  <c:v>0.62009691077138396</c:v>
                </c:pt>
                <c:pt idx="79">
                  <c:v>0.37676632442916502</c:v>
                </c:pt>
                <c:pt idx="80">
                  <c:v>0.50113046808846795</c:v>
                </c:pt>
                <c:pt idx="81">
                  <c:v>0.426726758148673</c:v>
                </c:pt>
                <c:pt idx="82">
                  <c:v>0.30457898326109201</c:v>
                </c:pt>
                <c:pt idx="83">
                  <c:v>0.53536731516103098</c:v>
                </c:pt>
                <c:pt idx="84">
                  <c:v>0.85619743402076698</c:v>
                </c:pt>
                <c:pt idx="85">
                  <c:v>2.07166808161438</c:v>
                </c:pt>
                <c:pt idx="86">
                  <c:v>0.73270376334917797</c:v>
                </c:pt>
                <c:pt idx="87">
                  <c:v>0.58661685025027099</c:v>
                </c:pt>
                <c:pt idx="88">
                  <c:v>0.24991984221060501</c:v>
                </c:pt>
                <c:pt idx="89">
                  <c:v>0.234511872144085</c:v>
                </c:pt>
                <c:pt idx="90">
                  <c:v>0.46828331138978002</c:v>
                </c:pt>
                <c:pt idx="91">
                  <c:v>0.81551300000000004</c:v>
                </c:pt>
                <c:pt idx="92">
                  <c:v>0.28281489859037401</c:v>
                </c:pt>
                <c:pt idx="93">
                  <c:v>0.375232532167873</c:v>
                </c:pt>
                <c:pt idx="94">
                  <c:v>0.992844012806538</c:v>
                </c:pt>
                <c:pt idx="95">
                  <c:v>0.29858627225207901</c:v>
                </c:pt>
                <c:pt idx="96">
                  <c:v>0.43663396317762698</c:v>
                </c:pt>
                <c:pt idx="97">
                  <c:v>-0.244781390799301</c:v>
                </c:pt>
                <c:pt idx="98">
                  <c:v>0.28255089258425198</c:v>
                </c:pt>
                <c:pt idx="99">
                  <c:v>-0.32985465891530202</c:v>
                </c:pt>
                <c:pt idx="100">
                  <c:v>0.40107148376857898</c:v>
                </c:pt>
                <c:pt idx="101">
                  <c:v>0.64676668178578101</c:v>
                </c:pt>
                <c:pt idx="102">
                  <c:v>0.24471665753373001</c:v>
                </c:pt>
                <c:pt idx="103">
                  <c:v>-9.2456971983065298E-3</c:v>
                </c:pt>
                <c:pt idx="104">
                  <c:v>0.112871485378627</c:v>
                </c:pt>
                <c:pt idx="105">
                  <c:v>-0.18531600000000001</c:v>
                </c:pt>
                <c:pt idx="106">
                  <c:v>-0.112720227622682</c:v>
                </c:pt>
                <c:pt idx="107">
                  <c:v>0.47887669999999999</c:v>
                </c:pt>
                <c:pt idx="108">
                  <c:v>-0.39707243065710501</c:v>
                </c:pt>
                <c:pt idx="109">
                  <c:v>0.18162301326704899</c:v>
                </c:pt>
                <c:pt idx="110">
                  <c:v>0.232076421294376</c:v>
                </c:pt>
                <c:pt idx="111">
                  <c:v>3.8185261509797799E-2</c:v>
                </c:pt>
                <c:pt idx="112">
                  <c:v>2.94211669074128E-3</c:v>
                </c:pt>
                <c:pt idx="113">
                  <c:v>0.91724730017850298</c:v>
                </c:pt>
                <c:pt idx="114">
                  <c:v>-0.14065214166436399</c:v>
                </c:pt>
              </c:numCache>
            </c:numRef>
          </c:xVal>
          <c:yVal>
            <c:numRef>
              <c:f>'thy logfc by logfc'!$L$2:$L$14894</c:f>
              <c:numCache>
                <c:formatCode>General</c:formatCode>
                <c:ptCount val="14893"/>
                <c:pt idx="0">
                  <c:v>3.1434548443337298</c:v>
                </c:pt>
                <c:pt idx="1">
                  <c:v>3.6740571190780371</c:v>
                </c:pt>
                <c:pt idx="2">
                  <c:v>0.82830594528249402</c:v>
                </c:pt>
                <c:pt idx="3">
                  <c:v>0.94398921661616597</c:v>
                </c:pt>
                <c:pt idx="4">
                  <c:v>1.76590648162312</c:v>
                </c:pt>
                <c:pt idx="5">
                  <c:v>0.827014118022671</c:v>
                </c:pt>
                <c:pt idx="6">
                  <c:v>0.73456367100044395</c:v>
                </c:pt>
                <c:pt idx="7">
                  <c:v>0.47482136438695199</c:v>
                </c:pt>
                <c:pt idx="8">
                  <c:v>0.51915994137307397</c:v>
                </c:pt>
                <c:pt idx="9">
                  <c:v>0.64457779926987802</c:v>
                </c:pt>
                <c:pt idx="10">
                  <c:v>0.60317191025462602</c:v>
                </c:pt>
                <c:pt idx="11">
                  <c:v>0.37591840658784298</c:v>
                </c:pt>
                <c:pt idx="12">
                  <c:v>0.58041232504465801</c:v>
                </c:pt>
                <c:pt idx="13">
                  <c:v>0.88283440000000002</c:v>
                </c:pt>
                <c:pt idx="14">
                  <c:v>0.38925107660404201</c:v>
                </c:pt>
                <c:pt idx="15">
                  <c:v>0.659600501602709</c:v>
                </c:pt>
                <c:pt idx="16">
                  <c:v>0.70906050981326596</c:v>
                </c:pt>
                <c:pt idx="17">
                  <c:v>0.75764790000000004</c:v>
                </c:pt>
                <c:pt idx="18">
                  <c:v>0.36599579089584799</c:v>
                </c:pt>
                <c:pt idx="19">
                  <c:v>0.929191914418529</c:v>
                </c:pt>
                <c:pt idx="20">
                  <c:v>0.30641630028076</c:v>
                </c:pt>
                <c:pt idx="21">
                  <c:v>0.75844217697249505</c:v>
                </c:pt>
                <c:pt idx="22">
                  <c:v>0.70051275355145204</c:v>
                </c:pt>
                <c:pt idx="23">
                  <c:v>1.09134808489101</c:v>
                </c:pt>
                <c:pt idx="24">
                  <c:v>0.61103371761984204</c:v>
                </c:pt>
                <c:pt idx="25">
                  <c:v>1.0007941594548899</c:v>
                </c:pt>
                <c:pt idx="26">
                  <c:v>0.57121601878127604</c:v>
                </c:pt>
                <c:pt idx="27">
                  <c:v>0.37906922995728198</c:v>
                </c:pt>
                <c:pt idx="28">
                  <c:v>0.48015025883157197</c:v>
                </c:pt>
                <c:pt idx="29">
                  <c:v>0.30477919756268101</c:v>
                </c:pt>
                <c:pt idx="30">
                  <c:v>0.43388471130756201</c:v>
                </c:pt>
                <c:pt idx="31">
                  <c:v>0.30730280698565898</c:v>
                </c:pt>
                <c:pt idx="32">
                  <c:v>0.26405745829710497</c:v>
                </c:pt>
                <c:pt idx="33">
                  <c:v>0.29125749075095603</c:v>
                </c:pt>
                <c:pt idx="34">
                  <c:v>0.27074106375825302</c:v>
                </c:pt>
                <c:pt idx="35">
                  <c:v>0.81225959776476298</c:v>
                </c:pt>
                <c:pt idx="36">
                  <c:v>1.53372618949786</c:v>
                </c:pt>
                <c:pt idx="37">
                  <c:v>0.41870313050394298</c:v>
                </c:pt>
                <c:pt idx="38">
                  <c:v>0.458437734331263</c:v>
                </c:pt>
                <c:pt idx="39">
                  <c:v>0.49182998550114898</c:v>
                </c:pt>
                <c:pt idx="40">
                  <c:v>-0.29739948923117299</c:v>
                </c:pt>
                <c:pt idx="41">
                  <c:v>0.38107015225597901</c:v>
                </c:pt>
                <c:pt idx="42">
                  <c:v>0.21481118474053901</c:v>
                </c:pt>
                <c:pt idx="43">
                  <c:v>0.522376849575377</c:v>
                </c:pt>
                <c:pt idx="44">
                  <c:v>1.23619934527801</c:v>
                </c:pt>
                <c:pt idx="45">
                  <c:v>0.52030308926915003</c:v>
                </c:pt>
                <c:pt idx="46">
                  <c:v>0.94780473261290399</c:v>
                </c:pt>
                <c:pt idx="47">
                  <c:v>0.33009891597651497</c:v>
                </c:pt>
                <c:pt idx="48">
                  <c:v>-0.16149012510709301</c:v>
                </c:pt>
                <c:pt idx="49">
                  <c:v>0.47094052148837101</c:v>
                </c:pt>
                <c:pt idx="50">
                  <c:v>0.213863003267039</c:v>
                </c:pt>
                <c:pt idx="51">
                  <c:v>0.35097486062592498</c:v>
                </c:pt>
                <c:pt idx="52">
                  <c:v>0.66458469390271502</c:v>
                </c:pt>
                <c:pt idx="53">
                  <c:v>0.21279792252594101</c:v>
                </c:pt>
                <c:pt idx="54">
                  <c:v>0.207402561416308</c:v>
                </c:pt>
                <c:pt idx="55">
                  <c:v>0.30221189318601299</c:v>
                </c:pt>
                <c:pt idx="56">
                  <c:v>0.659613035472844</c:v>
                </c:pt>
                <c:pt idx="57">
                  <c:v>0.77724255639634798</c:v>
                </c:pt>
                <c:pt idx="58">
                  <c:v>0.52593256984814296</c:v>
                </c:pt>
                <c:pt idx="59">
                  <c:v>0.74466556205895795</c:v>
                </c:pt>
                <c:pt idx="60">
                  <c:v>1.0638289999999999</c:v>
                </c:pt>
                <c:pt idx="61">
                  <c:v>0.36903710700660602</c:v>
                </c:pt>
                <c:pt idx="62">
                  <c:v>0.195445545908465</c:v>
                </c:pt>
                <c:pt idx="63">
                  <c:v>1.4848100156341399</c:v>
                </c:pt>
                <c:pt idx="64">
                  <c:v>0.13638969154202199</c:v>
                </c:pt>
                <c:pt idx="65">
                  <c:v>0.33571301647523499</c:v>
                </c:pt>
                <c:pt idx="66">
                  <c:v>0.484593751190393</c:v>
                </c:pt>
                <c:pt idx="67">
                  <c:v>0.57154633131997001</c:v>
                </c:pt>
                <c:pt idx="68">
                  <c:v>0.16993070176459699</c:v>
                </c:pt>
                <c:pt idx="69">
                  <c:v>1.08590290365588</c:v>
                </c:pt>
                <c:pt idx="70">
                  <c:v>0.57236658623296199</c:v>
                </c:pt>
                <c:pt idx="71">
                  <c:v>0.442983427388353</c:v>
                </c:pt>
                <c:pt idx="72">
                  <c:v>0.35251585268396501</c:v>
                </c:pt>
                <c:pt idx="73">
                  <c:v>0.17040556505784701</c:v>
                </c:pt>
                <c:pt idx="74">
                  <c:v>-0.176686435138149</c:v>
                </c:pt>
                <c:pt idx="75">
                  <c:v>0.463070479641643</c:v>
                </c:pt>
                <c:pt idx="76">
                  <c:v>0.13989944426581999</c:v>
                </c:pt>
                <c:pt idx="77">
                  <c:v>-0.18921783094849401</c:v>
                </c:pt>
                <c:pt idx="78">
                  <c:v>0.75052546572319101</c:v>
                </c:pt>
                <c:pt idx="79">
                  <c:v>0.33586838605569402</c:v>
                </c:pt>
                <c:pt idx="80">
                  <c:v>0.41880998744520198</c:v>
                </c:pt>
                <c:pt idx="81">
                  <c:v>0.53150579040041102</c:v>
                </c:pt>
                <c:pt idx="82">
                  <c:v>0.186352415987596</c:v>
                </c:pt>
                <c:pt idx="83">
                  <c:v>0.50579710340903705</c:v>
                </c:pt>
                <c:pt idx="84">
                  <c:v>0.86415063601107001</c:v>
                </c:pt>
                <c:pt idx="85">
                  <c:v>2.2169718151250999</c:v>
                </c:pt>
                <c:pt idx="86">
                  <c:v>0.63200007388402202</c:v>
                </c:pt>
                <c:pt idx="87">
                  <c:v>0.64610799126435203</c:v>
                </c:pt>
                <c:pt idx="88">
                  <c:v>0.23928611059450799</c:v>
                </c:pt>
                <c:pt idx="89">
                  <c:v>0.18967956423886001</c:v>
                </c:pt>
                <c:pt idx="90">
                  <c:v>0.40739914544711697</c:v>
                </c:pt>
                <c:pt idx="91">
                  <c:v>0.7814297</c:v>
                </c:pt>
                <c:pt idx="92">
                  <c:v>0.22445335110831599</c:v>
                </c:pt>
                <c:pt idx="93">
                  <c:v>0.255337613648983</c:v>
                </c:pt>
                <c:pt idx="94">
                  <c:v>1.01337906297794</c:v>
                </c:pt>
                <c:pt idx="95">
                  <c:v>0.27669415179029</c:v>
                </c:pt>
                <c:pt idx="96">
                  <c:v>0.43404991648152402</c:v>
                </c:pt>
                <c:pt idx="97">
                  <c:v>-0.400127281898569</c:v>
                </c:pt>
                <c:pt idx="98">
                  <c:v>0.39309028439205301</c:v>
                </c:pt>
                <c:pt idx="99">
                  <c:v>-0.64002214498696297</c:v>
                </c:pt>
                <c:pt idx="100">
                  <c:v>0.67633207801851403</c:v>
                </c:pt>
                <c:pt idx="101">
                  <c:v>1.0150267030678699</c:v>
                </c:pt>
                <c:pt idx="102">
                  <c:v>0.29717765886945402</c:v>
                </c:pt>
                <c:pt idx="103">
                  <c:v>-0.336600528113288</c:v>
                </c:pt>
                <c:pt idx="104">
                  <c:v>-0.51344712044116303</c:v>
                </c:pt>
                <c:pt idx="105">
                  <c:v>-0.58716550000000001</c:v>
                </c:pt>
                <c:pt idx="106">
                  <c:v>-0.34307714986247301</c:v>
                </c:pt>
                <c:pt idx="107">
                  <c:v>0.63716019999999995</c:v>
                </c:pt>
                <c:pt idx="108">
                  <c:v>-0.77471828484656302</c:v>
                </c:pt>
                <c:pt idx="109">
                  <c:v>0.25942160281486598</c:v>
                </c:pt>
                <c:pt idx="110">
                  <c:v>0.31007042004649099</c:v>
                </c:pt>
                <c:pt idx="111">
                  <c:v>1.45446895789673</c:v>
                </c:pt>
                <c:pt idx="112">
                  <c:v>-0.45503216356298498</c:v>
                </c:pt>
                <c:pt idx="113">
                  <c:v>1.3051888847819499</c:v>
                </c:pt>
                <c:pt idx="114">
                  <c:v>-0.280354249795738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3BC-4FD1-96F4-9EB71E6FAA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7959352"/>
        <c:axId val="-873679352"/>
      </c:scatterChart>
      <c:valAx>
        <c:axId val="2017959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73679352"/>
        <c:crosses val="autoZero"/>
        <c:crossBetween val="midCat"/>
      </c:valAx>
      <c:valAx>
        <c:axId val="-8736793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179593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5859301608417704E-2"/>
          <c:y val="4.6405099578301502E-2"/>
          <c:w val="0.87543343885692004"/>
          <c:h val="0.8557296346553420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2">
                  <a:lumMod val="50000"/>
                </a:schemeClr>
              </a:solidFill>
              <a:ln w="9525">
                <a:solidFill>
                  <a:schemeClr val="bg2">
                    <a:lumMod val="50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bg2">
                    <a:lumMod val="75000"/>
                  </a:schemeClr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-1.8133021702615E-2"/>
                  <c:y val="-4.3623125878799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glucose log fc by logFC'!$M$2:$M$14</c:f>
              <c:numCache>
                <c:formatCode>General</c:formatCode>
                <c:ptCount val="13"/>
                <c:pt idx="0">
                  <c:v>1.8364489742480401</c:v>
                </c:pt>
                <c:pt idx="1">
                  <c:v>0.52684176901480195</c:v>
                </c:pt>
                <c:pt idx="2">
                  <c:v>0.46275660318089001</c:v>
                </c:pt>
                <c:pt idx="3">
                  <c:v>1.0381480408264601</c:v>
                </c:pt>
                <c:pt idx="4">
                  <c:v>1.26018395892547</c:v>
                </c:pt>
                <c:pt idx="5">
                  <c:v>0.74516892338524798</c:v>
                </c:pt>
                <c:pt idx="6">
                  <c:v>0.98384109382156704</c:v>
                </c:pt>
                <c:pt idx="7">
                  <c:v>0.54744928808327897</c:v>
                </c:pt>
                <c:pt idx="8">
                  <c:v>0.39437655366950702</c:v>
                </c:pt>
                <c:pt idx="9">
                  <c:v>0.30979477851849702</c:v>
                </c:pt>
                <c:pt idx="10">
                  <c:v>1.72176745061866</c:v>
                </c:pt>
                <c:pt idx="11">
                  <c:v>0.65217475291121496</c:v>
                </c:pt>
                <c:pt idx="12">
                  <c:v>0.57655347744451402</c:v>
                </c:pt>
              </c:numCache>
            </c:numRef>
          </c:xVal>
          <c:yVal>
            <c:numRef>
              <c:f>'glucose log fc by logFC'!$P$2:$P$14</c:f>
              <c:numCache>
                <c:formatCode>General</c:formatCode>
                <c:ptCount val="13"/>
                <c:pt idx="0">
                  <c:v>2.0015247142770298</c:v>
                </c:pt>
                <c:pt idx="1">
                  <c:v>0.48442829309972602</c:v>
                </c:pt>
                <c:pt idx="2">
                  <c:v>0.47503545660963797</c:v>
                </c:pt>
                <c:pt idx="3">
                  <c:v>1.0553382166413801</c:v>
                </c:pt>
                <c:pt idx="4">
                  <c:v>1.3618470073884901</c:v>
                </c:pt>
                <c:pt idx="5">
                  <c:v>0.62688441284872198</c:v>
                </c:pt>
                <c:pt idx="6">
                  <c:v>0.90051839858771898</c:v>
                </c:pt>
                <c:pt idx="7">
                  <c:v>0.50142720428120702</c:v>
                </c:pt>
                <c:pt idx="8">
                  <c:v>0.32644635805622901</c:v>
                </c:pt>
                <c:pt idx="9">
                  <c:v>0.19556748655448999</c:v>
                </c:pt>
                <c:pt idx="10">
                  <c:v>1.1122764509037</c:v>
                </c:pt>
                <c:pt idx="11">
                  <c:v>0.54781386352218198</c:v>
                </c:pt>
                <c:pt idx="12">
                  <c:v>0.505363700228236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64F-4F36-84A1-1AE240704A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48578360"/>
        <c:axId val="2048564920"/>
      </c:scatterChart>
      <c:valAx>
        <c:axId val="2048578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8564920"/>
        <c:crosses val="autoZero"/>
        <c:crossBetween val="midCat"/>
      </c:valAx>
      <c:valAx>
        <c:axId val="20485649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85783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2C1F7B-3D7C-4D8D-92F7-D6DD605563C4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68E604-A9B7-498C-B267-68F0DF827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642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roliferation of human islets in response to T3 and glucose. </a:t>
            </a:r>
            <a:br>
              <a:rPr lang="en-US" dirty="0"/>
            </a:br>
            <a:r>
              <a:rPr lang="en-US" dirty="0"/>
              <a:t>Overall proliferation within and islet is maximal in high glucose. However, Insulin percentage is the highest in low glucos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4BE8A-7A8A-46DE-B40E-2001DC61BCB7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5658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4BE8A-7A8A-46DE-B40E-2001DC61BCB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1979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4BE8A-7A8A-46DE-B40E-2001DC61BCB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2145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4BE8A-7A8A-46DE-B40E-2001DC61BCB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2937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14BE8A-7A8A-46DE-B40E-2001DC61BCB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954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980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593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557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623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52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235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438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667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403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06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24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5F72ED-5CF9-4827-ABD7-84CC3B40DCD7}" type="datetimeFigureOut">
              <a:rPr lang="en-US" smtClean="0"/>
              <a:t>11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D3843-F06A-4E02-B22F-D69FB8EC5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468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oleObject" Target="../embeddings/oleObject1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2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en-US" dirty="0">
                <a:solidFill>
                  <a:schemeClr val="tx2"/>
                </a:solidFill>
              </a:rPr>
              <a:t>T3 and Glucose Signaling in Pancreatic </a:t>
            </a:r>
            <a:r>
              <a:rPr lang="el-GR" altLang="en-US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en-US" dirty="0">
                <a:solidFill>
                  <a:schemeClr val="tx2"/>
                </a:solidFill>
              </a:rPr>
              <a:t>-Cells</a:t>
            </a:r>
            <a:br>
              <a:rPr lang="en-US" altLang="en-US" dirty="0">
                <a:solidFill>
                  <a:schemeClr val="tx2"/>
                </a:solidFill>
              </a:rPr>
            </a:b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upplementary Figures and Tables</a:t>
            </a:r>
          </a:p>
        </p:txBody>
      </p:sp>
    </p:spTree>
    <p:extLst>
      <p:ext uri="{BB962C8B-B14F-4D97-AF65-F5344CB8AC3E}">
        <p14:creationId xmlns:p14="http://schemas.microsoft.com/office/powerpoint/2010/main" val="435805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026" y="2147828"/>
            <a:ext cx="5420485" cy="439059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08308" y="2043953"/>
            <a:ext cx="13051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ementary Figure </a:t>
            </a:r>
            <a:r>
              <a:rPr lang="en-US" sz="900" dirty="0" smtClean="0"/>
              <a:t>5</a:t>
            </a:r>
            <a:endParaRPr lang="en-US" sz="900" dirty="0"/>
          </a:p>
        </p:txBody>
      </p:sp>
      <p:sp>
        <p:nvSpPr>
          <p:cNvPr id="4" name="Oval 3"/>
          <p:cNvSpPr/>
          <p:nvPr/>
        </p:nvSpPr>
        <p:spPr>
          <a:xfrm>
            <a:off x="4045882" y="6002949"/>
            <a:ext cx="151667" cy="13847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5" name="Oval 4"/>
          <p:cNvSpPr/>
          <p:nvPr/>
        </p:nvSpPr>
        <p:spPr>
          <a:xfrm>
            <a:off x="4045882" y="6208408"/>
            <a:ext cx="151667" cy="138479"/>
          </a:xfrm>
          <a:prstGeom prst="ellipse">
            <a:avLst/>
          </a:prstGeom>
          <a:solidFill>
            <a:schemeClr val="accent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6" name="TextBox 5"/>
          <p:cNvSpPr txBox="1"/>
          <p:nvPr/>
        </p:nvSpPr>
        <p:spPr>
          <a:xfrm>
            <a:off x="4197548" y="5939538"/>
            <a:ext cx="16225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Glucose up-regulated DE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97548" y="6183505"/>
            <a:ext cx="17892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Glucose down-regulated DEG</a:t>
            </a:r>
          </a:p>
        </p:txBody>
      </p:sp>
    </p:spTree>
    <p:extLst>
      <p:ext uri="{BB962C8B-B14F-4D97-AF65-F5344CB8AC3E}">
        <p14:creationId xmlns:p14="http://schemas.microsoft.com/office/powerpoint/2010/main" val="3186942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267" y="2161383"/>
            <a:ext cx="5603776" cy="49823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2100616"/>
            <a:ext cx="3016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159" y="4652567"/>
            <a:ext cx="2952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0843" y="1699634"/>
            <a:ext cx="13019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ementary Figure </a:t>
            </a:r>
            <a:r>
              <a:rPr lang="en-US" sz="900" dirty="0" smtClean="0"/>
              <a:t>6</a:t>
            </a:r>
            <a:endParaRPr lang="en-US" sz="900" dirty="0"/>
          </a:p>
        </p:txBody>
      </p:sp>
      <p:sp>
        <p:nvSpPr>
          <p:cNvPr id="8" name="Oval 7"/>
          <p:cNvSpPr/>
          <p:nvPr/>
        </p:nvSpPr>
        <p:spPr>
          <a:xfrm>
            <a:off x="5020478" y="6154616"/>
            <a:ext cx="151667" cy="13847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9" name="Oval 8"/>
          <p:cNvSpPr/>
          <p:nvPr/>
        </p:nvSpPr>
        <p:spPr>
          <a:xfrm>
            <a:off x="5020478" y="6360075"/>
            <a:ext cx="151667" cy="138479"/>
          </a:xfrm>
          <a:prstGeom prst="ellipse">
            <a:avLst/>
          </a:prstGeom>
          <a:solidFill>
            <a:schemeClr val="accent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0" name="TextBox 9"/>
          <p:cNvSpPr txBox="1"/>
          <p:nvPr/>
        </p:nvSpPr>
        <p:spPr>
          <a:xfrm>
            <a:off x="5172145" y="6091205"/>
            <a:ext cx="13227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T3 up-regulated DE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72145" y="6335172"/>
            <a:ext cx="148951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T3 down-regulated DEG</a:t>
            </a:r>
          </a:p>
        </p:txBody>
      </p:sp>
    </p:spTree>
    <p:extLst>
      <p:ext uri="{BB962C8B-B14F-4D97-AF65-F5344CB8AC3E}">
        <p14:creationId xmlns:p14="http://schemas.microsoft.com/office/powerpoint/2010/main" val="203009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085" y="2306939"/>
            <a:ext cx="6142857" cy="3142857"/>
          </a:xfrm>
          <a:prstGeom prst="rect">
            <a:avLst/>
          </a:prstGeom>
        </p:spPr>
      </p:pic>
      <p:sp>
        <p:nvSpPr>
          <p:cNvPr id="9" name="Oval 8"/>
          <p:cNvSpPr/>
          <p:nvPr/>
        </p:nvSpPr>
        <p:spPr>
          <a:xfrm>
            <a:off x="4833572" y="5620483"/>
            <a:ext cx="151667" cy="13847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0" name="Oval 9"/>
          <p:cNvSpPr/>
          <p:nvPr/>
        </p:nvSpPr>
        <p:spPr>
          <a:xfrm>
            <a:off x="4833572" y="5825942"/>
            <a:ext cx="151667" cy="138479"/>
          </a:xfrm>
          <a:prstGeom prst="ellipse">
            <a:avLst/>
          </a:prstGeom>
          <a:solidFill>
            <a:schemeClr val="accent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1" name="TextBox 10"/>
          <p:cNvSpPr txBox="1"/>
          <p:nvPr/>
        </p:nvSpPr>
        <p:spPr>
          <a:xfrm>
            <a:off x="4985239" y="5557073"/>
            <a:ext cx="13227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T3 up-regulated DEG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85239" y="5801039"/>
            <a:ext cx="16225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Glucose up-regulated DEG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6159" y="2032378"/>
            <a:ext cx="13051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ementary Figure </a:t>
            </a:r>
            <a:r>
              <a:rPr lang="en-US" sz="900" dirty="0" smtClean="0"/>
              <a:t>7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606290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4800" y="350520"/>
            <a:ext cx="541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8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9768" y="1547985"/>
            <a:ext cx="5881161" cy="4389120"/>
          </a:xfrm>
          <a:prstGeom prst="rect">
            <a:avLst/>
          </a:prstGeom>
        </p:spPr>
      </p:pic>
      <p:sp>
        <p:nvSpPr>
          <p:cNvPr id="5" name="Left Brace 4"/>
          <p:cNvSpPr/>
          <p:nvPr/>
        </p:nvSpPr>
        <p:spPr>
          <a:xfrm>
            <a:off x="628650" y="1574976"/>
            <a:ext cx="264265" cy="22860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0" y="2225766"/>
            <a:ext cx="74676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/>
              <a:t>ChREBP</a:t>
            </a:r>
            <a:r>
              <a:rPr lang="en-US" sz="1400" dirty="0" smtClean="0"/>
              <a:t> and THR</a:t>
            </a:r>
          </a:p>
          <a:p>
            <a:r>
              <a:rPr lang="en-US" sz="1400" dirty="0" smtClean="0"/>
              <a:t>Binding sites</a:t>
            </a:r>
            <a:endParaRPr lang="en-US" sz="1400" dirty="0"/>
          </a:p>
        </p:txBody>
      </p:sp>
      <p:sp>
        <p:nvSpPr>
          <p:cNvPr id="7" name="Left Brace 6"/>
          <p:cNvSpPr/>
          <p:nvPr/>
        </p:nvSpPr>
        <p:spPr>
          <a:xfrm>
            <a:off x="641833" y="3950227"/>
            <a:ext cx="264265" cy="173045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0" y="4446124"/>
            <a:ext cx="7467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/>
              <a:t>ChREBP</a:t>
            </a:r>
            <a:r>
              <a:rPr lang="en-US" sz="1400" dirty="0" smtClean="0"/>
              <a:t> Binding sites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102976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632158-3181-01BE-FF4D-4C66E75A1A4C}"/>
              </a:ext>
            </a:extLst>
          </p:cNvPr>
          <p:cNvSpPr txBox="1"/>
          <p:nvPr/>
        </p:nvSpPr>
        <p:spPr>
          <a:xfrm>
            <a:off x="304800" y="350520"/>
            <a:ext cx="541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9</a:t>
            </a:r>
            <a:endParaRPr lang="en-US" dirty="0"/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DF548B04-648C-9DBD-DBCF-CAE168C1FDE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3667" y="1068209"/>
            <a:ext cx="1921005" cy="914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A2B01EF-90EC-6D6E-9902-069A0FF08B06}"/>
              </a:ext>
            </a:extLst>
          </p:cNvPr>
          <p:cNvSpPr txBox="1"/>
          <p:nvPr/>
        </p:nvSpPr>
        <p:spPr>
          <a:xfrm>
            <a:off x="2658532" y="2300136"/>
            <a:ext cx="2286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C           G          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F6097F-27C2-892F-AB4F-111A37829A02}"/>
              </a:ext>
            </a:extLst>
          </p:cNvPr>
          <p:cNvSpPr txBox="1"/>
          <p:nvPr/>
        </p:nvSpPr>
        <p:spPr>
          <a:xfrm>
            <a:off x="2135226" y="2590444"/>
            <a:ext cx="328936" cy="29177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sz="1200" spc="-50" dirty="0"/>
              <a:t>1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2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3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4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5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6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7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8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9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0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1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2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3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4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5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6</a:t>
            </a:r>
          </a:p>
          <a:p>
            <a:pPr algn="ctr">
              <a:lnSpc>
                <a:spcPct val="90000"/>
              </a:lnSpc>
            </a:pPr>
            <a:r>
              <a:rPr lang="en-US" sz="1200" spc="-50" dirty="0"/>
              <a:t>17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AFA3673-F9D6-ADAA-B494-8A422BFDCF59}"/>
              </a:ext>
            </a:extLst>
          </p:cNvPr>
          <p:cNvSpPr txBox="1"/>
          <p:nvPr/>
        </p:nvSpPr>
        <p:spPr>
          <a:xfrm>
            <a:off x="1794625" y="3627138"/>
            <a:ext cx="461665" cy="84433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dirty="0"/>
              <a:t>Posit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623A44-D193-B20D-385E-DAB17D1BAB38}"/>
              </a:ext>
            </a:extLst>
          </p:cNvPr>
          <p:cNvSpPr txBox="1"/>
          <p:nvPr/>
        </p:nvSpPr>
        <p:spPr>
          <a:xfrm>
            <a:off x="2679274" y="2064850"/>
            <a:ext cx="2244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cleotide Frequency</a:t>
            </a:r>
          </a:p>
        </p:txBody>
      </p:sp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56F92F52-5382-FB21-8A75-E63CE4DA4EF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0" y="2642616"/>
            <a:ext cx="2560320" cy="2765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9227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271235" y="645997"/>
          <a:ext cx="5878799" cy="6034082"/>
        </p:xfrm>
        <a:graphic>
          <a:graphicData uri="http://schemas.openxmlformats.org/drawingml/2006/table">
            <a:tbl>
              <a:tblPr/>
              <a:tblGrid>
                <a:gridCol w="499817">
                  <a:extLst>
                    <a:ext uri="{9D8B030D-6E8A-4147-A177-3AD203B41FA5}">
                      <a16:colId xmlns:a16="http://schemas.microsoft.com/office/drawing/2014/main" val="2934061319"/>
                    </a:ext>
                  </a:extLst>
                </a:gridCol>
                <a:gridCol w="1213841">
                  <a:extLst>
                    <a:ext uri="{9D8B030D-6E8A-4147-A177-3AD203B41FA5}">
                      <a16:colId xmlns:a16="http://schemas.microsoft.com/office/drawing/2014/main" val="1962981848"/>
                    </a:ext>
                  </a:extLst>
                </a:gridCol>
                <a:gridCol w="1983400">
                  <a:extLst>
                    <a:ext uri="{9D8B030D-6E8A-4147-A177-3AD203B41FA5}">
                      <a16:colId xmlns:a16="http://schemas.microsoft.com/office/drawing/2014/main" val="3306841619"/>
                    </a:ext>
                  </a:extLst>
                </a:gridCol>
                <a:gridCol w="2181741">
                  <a:extLst>
                    <a:ext uri="{9D8B030D-6E8A-4147-A177-3AD203B41FA5}">
                      <a16:colId xmlns:a16="http://schemas.microsoft.com/office/drawing/2014/main" val="4036002126"/>
                    </a:ext>
                  </a:extLst>
                </a:gridCol>
              </a:tblGrid>
              <a:tr h="177473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pplementary Table 1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092561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uman primers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2238534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ward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2689384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CGGACTCGGACACAGA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GCTCAAGCACTCGAA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2625262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CAGGTCGAGCGGAT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CTGTGTCCGAGTCCGAG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831728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l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GTGATTGTGGTGACAG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GGCTGGAGAACGTAGAC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24352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nip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TGTGAAGTTACTCGTGTCAA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GGTACTCCGAAGTCTG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377733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k1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AACGGCCTGAACCTCTC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ACAGCTCAGCGTTATTCTC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838938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actin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CTTCCCCTCCATCGT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GTGTGGTGCCAGATTTT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8069038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040019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use primers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8468420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ward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9765206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ACACTCACCCACCTCTT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TTCAGCCGGATCTTGT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786401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TGCAGATCGCGTG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GTCCCGGCATAGCAA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6252107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l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AAGGCAGGGATGAACATT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GGGTCTGTAGCTGAGT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617655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nip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GGGTGGAGTGCTTA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ATGGAGGCACAGTGAG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4252832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actin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CCATGTACGTCCATC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CAGCTGTGGTGGTGA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202479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k1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CATTCAACGCCAGGTTC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AGTCTGTCAGTTCAATACCA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8897227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231057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 primers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6316127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ward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3753255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CATCGATCACAGGTCAT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GCTCAAGCATTCGAA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5446081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β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TGCAGATCGCGCG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GTCCCGGCATAGCA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04557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kl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GGAGCACGGTGGTATCT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CACGCCTTCATGGTTC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28914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xnip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ATGGAGGCACAGTGAG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CGGGTGGAGTGCTTAG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1868691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actin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CACCCCAGCCATGTACGTA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ACCGCTCATTGCCGATAGT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258473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a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Calibri" panose="020F0502020204030204" pitchFamily="34" charset="0"/>
                        </a:rPr>
                        <a:t>TGGACCTGGTTCTAGACGATTCA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Calibri" panose="020F0502020204030204" pitchFamily="34" charset="0"/>
                        </a:rPr>
                        <a:t>TCCCGGTTCTGCTCAATCA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179015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b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Calibri" panose="020F0502020204030204" pitchFamily="34" charset="0"/>
                        </a:rPr>
                        <a:t>CTCTGTCGTCTTTCAACCTGGAT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212121"/>
                          </a:solidFill>
                          <a:effectLst/>
                          <a:latin typeface="Calibri" panose="020F0502020204030204" pitchFamily="34" charset="0"/>
                        </a:rPr>
                        <a:t>TGGGCGATCTGAAGACATCA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6937269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5451573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 ChIP Primers</a:t>
                      </a: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9864786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ward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306411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ORE on 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</a:rPr>
                        <a:t>β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TGTATGCCTATGGGCTTGG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CTATGGCCAGTCAGGTTGC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495646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E on ChREBP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</a:rPr>
                        <a:t>β</a:t>
                      </a:r>
                      <a:endParaRPr lang="el-G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TGGTGCCCTGGGTATGAG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ATATGATGCAGTGTGTTGTACCT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8459625"/>
                  </a:ext>
                </a:extLst>
              </a:tr>
              <a:tr h="177473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95" marR="7395" marT="739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B coding</a:t>
                      </a:r>
                    </a:p>
                  </a:txBody>
                  <a:tcPr marL="7395" marR="7395" marT="739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AGCCATGTACGTAGCCATCC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CTCTCAGCTGTGGTGGTGAA</a:t>
                      </a:r>
                    </a:p>
                  </a:txBody>
                  <a:tcPr marL="7395" marR="7395" marT="739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60392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11075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51532" y="364694"/>
            <a:ext cx="56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 Table 2</a:t>
            </a:r>
            <a:endParaRPr lang="en-US" b="1" dirty="0">
              <a:solidFill>
                <a:srgbClr val="FF0000"/>
              </a:solidFill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381000" y="1289185"/>
          <a:ext cx="5611380" cy="15011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35230">
                  <a:extLst>
                    <a:ext uri="{9D8B030D-6E8A-4147-A177-3AD203B41FA5}">
                      <a16:colId xmlns:a16="http://schemas.microsoft.com/office/drawing/2014/main" val="949456659"/>
                    </a:ext>
                  </a:extLst>
                </a:gridCol>
                <a:gridCol w="935230">
                  <a:extLst>
                    <a:ext uri="{9D8B030D-6E8A-4147-A177-3AD203B41FA5}">
                      <a16:colId xmlns:a16="http://schemas.microsoft.com/office/drawing/2014/main" val="3550263736"/>
                    </a:ext>
                  </a:extLst>
                </a:gridCol>
                <a:gridCol w="935230">
                  <a:extLst>
                    <a:ext uri="{9D8B030D-6E8A-4147-A177-3AD203B41FA5}">
                      <a16:colId xmlns:a16="http://schemas.microsoft.com/office/drawing/2014/main" val="1852862660"/>
                    </a:ext>
                  </a:extLst>
                </a:gridCol>
                <a:gridCol w="1156710">
                  <a:extLst>
                    <a:ext uri="{9D8B030D-6E8A-4147-A177-3AD203B41FA5}">
                      <a16:colId xmlns:a16="http://schemas.microsoft.com/office/drawing/2014/main" val="3582981928"/>
                    </a:ext>
                  </a:extLst>
                </a:gridCol>
                <a:gridCol w="713750">
                  <a:extLst>
                    <a:ext uri="{9D8B030D-6E8A-4147-A177-3AD203B41FA5}">
                      <a16:colId xmlns:a16="http://schemas.microsoft.com/office/drawing/2014/main" val="3947758317"/>
                    </a:ext>
                  </a:extLst>
                </a:gridCol>
                <a:gridCol w="935230">
                  <a:extLst>
                    <a:ext uri="{9D8B030D-6E8A-4147-A177-3AD203B41FA5}">
                      <a16:colId xmlns:a16="http://schemas.microsoft.com/office/drawing/2014/main" val="3340545149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</a:rPr>
                        <a:t>Dono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</a:rPr>
                        <a:t>DONOR IIDP ID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</a:rPr>
                        <a:t>Gend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</a:rPr>
                        <a:t>Rac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>
                          <a:effectLst/>
                        </a:rPr>
                        <a:t>Ag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BM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9857704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HL2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ale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Hispanic/Latin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827619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IY1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ale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hit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.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7959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IZ127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Fema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lack or African Americ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8364888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P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CJV1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ale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Black or African America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.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237958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CJY3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Fema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Wh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79981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44113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BCB029-8444-F2EB-B65D-F6CE7E1DBE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3852" y="441722"/>
            <a:ext cx="5395695" cy="85953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D6C02BB-3813-7F63-8B48-C14EE7F9D5F0}"/>
              </a:ext>
            </a:extLst>
          </p:cNvPr>
          <p:cNvSpPr txBox="1"/>
          <p:nvPr/>
        </p:nvSpPr>
        <p:spPr>
          <a:xfrm>
            <a:off x="7032" y="5318"/>
            <a:ext cx="56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 Table 3</a:t>
            </a:r>
            <a:endParaRPr lang="en-US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20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D6C02BB-3813-7F63-8B48-C14EE7F9D5F0}"/>
              </a:ext>
            </a:extLst>
          </p:cNvPr>
          <p:cNvSpPr txBox="1"/>
          <p:nvPr/>
        </p:nvSpPr>
        <p:spPr>
          <a:xfrm>
            <a:off x="7032" y="5318"/>
            <a:ext cx="5632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 Table 4</a:t>
            </a:r>
            <a:endParaRPr lang="en-US" b="1" dirty="0">
              <a:solidFill>
                <a:srgbClr val="FF0000"/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9022239-A5FB-9446-114B-E2B47D582D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08" y="1311635"/>
            <a:ext cx="3374136" cy="61703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E525B62-EDB0-E06C-7E10-9117963EF5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6932" y="1311626"/>
            <a:ext cx="3374136" cy="6070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79230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60960" y="-554956"/>
            <a:ext cx="6172200" cy="1524000"/>
          </a:xfrm>
        </p:spPr>
        <p:txBody>
          <a:bodyPr>
            <a:normAutofit/>
          </a:bodyPr>
          <a:lstStyle/>
          <a:p>
            <a:pPr algn="l"/>
            <a:r>
              <a:rPr lang="en-US" sz="2000" dirty="0"/>
              <a:t>Supplemental Figure 1: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04800" y="599712"/>
            <a:ext cx="297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     All cell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04800" y="4721225"/>
            <a:ext cx="297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      percent of All cells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/>
          </p:nvPr>
        </p:nvGraphicFramePr>
        <p:xfrm>
          <a:off x="-133350" y="1158875"/>
          <a:ext cx="6991350" cy="333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4" imgW="6438142" imgH="3067593" progId="Prism9.Document">
                  <p:embed/>
                </p:oleObj>
              </mc:Choice>
              <mc:Fallback>
                <p:oleObj name="Prism 9" r:id="rId4" imgW="6438142" imgH="3067593" progId="Prism9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133350" y="1158875"/>
                        <a:ext cx="6991350" cy="3330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995" y="5273678"/>
            <a:ext cx="6429210" cy="2622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299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/>
          <p:cNvGraphicFramePr>
            <a:graphicFrameLocks noChangeAspect="1"/>
          </p:cNvGraphicFramePr>
          <p:nvPr>
            <p:extLst/>
          </p:nvPr>
        </p:nvGraphicFramePr>
        <p:xfrm>
          <a:off x="5197115" y="4028732"/>
          <a:ext cx="800100" cy="236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Worksheet" r:id="rId4" imgW="800174" imgH="236010" progId="Excel.Sheet.12">
                  <p:embed/>
                </p:oleObj>
              </mc:Choice>
              <mc:Fallback>
                <p:oleObj name="Worksheet" r:id="rId4" imgW="800174" imgH="236010" progId="Excel.Sheet.12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97115" y="4028732"/>
                        <a:ext cx="800100" cy="236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970870" y="4265269"/>
            <a:ext cx="17410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xpression level, fold over basal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942589" y="4019048"/>
            <a:ext cx="1857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                                 14</a:t>
            </a:r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/>
          </p:nvPr>
        </p:nvGraphicFramePr>
        <p:xfrm>
          <a:off x="39716" y="1324890"/>
          <a:ext cx="6741100" cy="21253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Worksheet" r:id="rId6" imgW="8862045" imgH="2789078" progId="Excel.Sheet.12">
                  <p:embed/>
                </p:oleObj>
              </mc:Choice>
              <mc:Fallback>
                <p:oleObj name="Worksheet" r:id="rId6" imgW="8862045" imgH="2789078" progId="Excel.Sheet.12">
                  <p:embed/>
                  <p:pic>
                    <p:nvPicPr>
                      <p:cNvPr id="21" name="Object 2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716" y="1324890"/>
                        <a:ext cx="6741100" cy="21253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Rectangle 22"/>
          <p:cNvSpPr/>
          <p:nvPr/>
        </p:nvSpPr>
        <p:spPr>
          <a:xfrm>
            <a:off x="58570" y="248967"/>
            <a:ext cx="23487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upplemental Figure </a:t>
            </a:r>
            <a:r>
              <a:rPr lang="en-US" dirty="0" smtClean="0"/>
              <a:t>2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0771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364944" y="2641759"/>
          <a:ext cx="3044462" cy="21878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/>
        </p:nvGraphicFramePr>
        <p:xfrm>
          <a:off x="3653246" y="2509867"/>
          <a:ext cx="2694215" cy="2013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573212" y="4621903"/>
            <a:ext cx="12731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g FC T3 (low glucose)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397926" y="3315631"/>
            <a:ext cx="13179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g FC T3 (High glucose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700011" y="4587278"/>
            <a:ext cx="15408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g FC Glucose effect (no T3)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2717642" y="3315630"/>
            <a:ext cx="16273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Log FC Glucose effect (with T3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61068" y="2153023"/>
            <a:ext cx="13051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ementary Figure </a:t>
            </a:r>
            <a:r>
              <a:rPr lang="en-US" sz="900" dirty="0" smtClean="0"/>
              <a:t>3</a:t>
            </a:r>
            <a:endParaRPr lang="en-US" sz="900" dirty="0"/>
          </a:p>
        </p:txBody>
      </p:sp>
      <p:sp>
        <p:nvSpPr>
          <p:cNvPr id="4" name="TextBox 3"/>
          <p:cNvSpPr txBox="1"/>
          <p:nvPr/>
        </p:nvSpPr>
        <p:spPr>
          <a:xfrm>
            <a:off x="261068" y="2509867"/>
            <a:ext cx="3299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2802286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893" y="2688861"/>
            <a:ext cx="3191825" cy="250563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3682" y="2688862"/>
            <a:ext cx="3204822" cy="250563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8212" y="2462705"/>
            <a:ext cx="3124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A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392834" y="2483561"/>
            <a:ext cx="3124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B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61068" y="2153023"/>
            <a:ext cx="13067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ementary Figure </a:t>
            </a:r>
            <a:r>
              <a:rPr lang="en-US" sz="900" dirty="0" smtClean="0"/>
              <a:t>4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727165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50</Words>
  <Application>Microsoft Office PowerPoint</Application>
  <PresentationFormat>On-screen Show (4:3)</PresentationFormat>
  <Paragraphs>181</Paragraphs>
  <Slides>14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4</vt:i4>
      </vt:variant>
    </vt:vector>
  </HeadingPairs>
  <TitlesOfParts>
    <vt:vector size="23" baseType="lpstr">
      <vt:lpstr>Arial</vt:lpstr>
      <vt:lpstr>Arial Unicode MS</vt:lpstr>
      <vt:lpstr>Calibri</vt:lpstr>
      <vt:lpstr>Calibri Light</vt:lpstr>
      <vt:lpstr>Corbel</vt:lpstr>
      <vt:lpstr>Verdana</vt:lpstr>
      <vt:lpstr>Office Theme</vt:lpstr>
      <vt:lpstr>Prism 9</vt:lpstr>
      <vt:lpstr>Worksheet</vt:lpstr>
      <vt:lpstr>T3 and Glucose Signaling in Pancreatic β-Cells </vt:lpstr>
      <vt:lpstr>PowerPoint Presentation</vt:lpstr>
      <vt:lpstr>PowerPoint Presentation</vt:lpstr>
      <vt:lpstr>PowerPoint Presentation</vt:lpstr>
      <vt:lpstr>PowerPoint Presentation</vt:lpstr>
      <vt:lpstr>Supplemental Figure 1: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Mount Sinai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3 and Glucose Signaling in Pancreatic β-Cells </dc:title>
  <dc:creator>Liora Katz</dc:creator>
  <cp:lastModifiedBy>Katz, Liora</cp:lastModifiedBy>
  <cp:revision>2</cp:revision>
  <dcterms:created xsi:type="dcterms:W3CDTF">2022-11-23T14:36:08Z</dcterms:created>
  <dcterms:modified xsi:type="dcterms:W3CDTF">2022-11-23T14:38:20Z</dcterms:modified>
</cp:coreProperties>
</file>